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72" autoAdjust="0"/>
    <p:restoredTop sz="94660"/>
  </p:normalViewPr>
  <p:slideViewPr>
    <p:cSldViewPr snapToGrid="0">
      <p:cViewPr varScale="1">
        <p:scale>
          <a:sx n="81" d="100"/>
          <a:sy n="81" d="100"/>
        </p:scale>
        <p:origin x="75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2E12E9-BD79-7BF2-1409-C95D7BD6D3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7779EF-86CE-353E-BC5C-19BFE2AA13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BC9BB4-C45B-B58F-C107-868284227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64B08D-1A3C-0B26-84F4-907CD8E56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4C94A7-B76D-A8BB-623E-9911DC907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59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16BCE2-A03F-A51B-F173-B79517A8EA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97BBE0-863B-E43B-2B53-A44F7E57E4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9D6228-DC56-2905-E454-0E7A5222A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214F09-9044-5D19-CD44-8C5920184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77A51B-B386-FB2E-4436-0525EE614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812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647165-A736-E067-B92F-0F796B6749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7A601A-0871-0C66-36FE-6101A75B45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20ABCD-E1D5-000B-EC27-2D8CE63DB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FE6B74-9906-194E-6E61-D1F7112D6E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D49E91-45D1-97AE-99E0-A2770F2AF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319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2A085-4D6D-2C64-E6FD-F79BBCF9E4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C36481-BAE0-0D01-3902-3AB0C80631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ACD81E-DCF3-C886-D834-B97CE52C4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E8C756-8A07-A210-031F-B3FE258176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EDCB32-A80C-C844-AF56-363F7E8A1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125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F82CA-A75D-5F6D-6BE8-F98873CBAB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C51E3B-904B-193A-D05A-820E156C13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D9C670-D248-1068-B274-E86A379ED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F7842E-3145-E098-9019-60164AECD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66D3DF-97AF-EF4B-7530-57DC8AD11E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29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D92B53-1D8D-36C6-0539-08B22929C2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CA87C6-8744-7245-E97F-F61485C76A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C95389-929E-358D-3597-4D06CE4A53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EF63DF-21C9-0795-B131-E57A612C5E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5410B5-DE94-B372-3FAA-A7644E9E3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4BC363-B9BD-2D0F-0D33-3B5F44DB3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931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FB531D-FD9F-A663-1CB0-AECDB673F4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9A951A-12BF-BAF6-2856-462BBD851A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DB7393-1F9D-8E5A-124E-55B4529FD9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3589706-0B52-8514-F702-607E889C7A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3739759-DDC0-481E-18F1-C0FB9E5BD5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0BC3576-E489-0BF0-CD99-6140C8C2A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ADC585C-3F7E-49AE-3E49-EF91D20C8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B2CD47-27BE-7DEC-1A5B-0383E4C466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613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02A854-0B6F-5A44-993A-BC914915D6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EDF4ADE-1192-5311-98E9-4FE07CF30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605C06-AAAD-7A2F-7878-A28252B0E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78B8DC-D259-DF18-C517-CA93CFBCB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872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3A3F29-21E7-644D-96D0-E52D29690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E316E24-41BC-5BD4-B889-C2000E2C7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E7D471-2C29-E798-5BD9-F3D149289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411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35789F-9248-E5F2-4C94-3AF0B8FC55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17E13F-F0D4-0951-7867-CC36D65C85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962E48-3EF3-BD1D-92A6-CA094BCA86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D5CAD4-5741-835E-9D65-E88505B68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6FECE5-D200-61C0-67F1-E2F8C19035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009665-5B8A-4362-8105-6FCA73AB2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249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7D3768-0E79-FBF7-CD28-FFC7CACA8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035929-9109-111B-AC75-B0376452C3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79EEF5-41DC-7AC7-0EFF-742480A88D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8CB4E0-DF01-6DC4-3BF0-296A24D165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C323D7-6D31-19AD-787D-7B5099933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CE8A17-ADBB-9BB9-05ED-B28BF1E8A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588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A4FB89-5140-825F-2815-35A4EA12AC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6B2B6E-D46D-C24E-67FA-6623E85F54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8AD66B-2685-31FC-ED43-A858BD7D9F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1FB0E4-59FF-1C6C-F9FE-998298E527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D1F8FF-3A12-79C4-2B92-D06006BDE8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15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E199DE-D8AD-F917-D32D-FBC3D1908C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7687" y="321085"/>
            <a:ext cx="9144000" cy="376499"/>
          </a:xfrm>
        </p:spPr>
        <p:txBody>
          <a:bodyPr>
            <a:noAutofit/>
          </a:bodyPr>
          <a:lstStyle/>
          <a:p>
            <a:pPr algn="l"/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2: HMGB-1 protein expression by Immunohistochemistry in NSCLC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26D5CAA-7598-7A73-FA61-D06A79BA63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8701" y="950536"/>
            <a:ext cx="4329889" cy="2556235"/>
          </a:xfrm>
          <a:prstGeom prst="rect">
            <a:avLst/>
          </a:prstGeom>
          <a:noFill/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5F8452D-46BE-3053-4849-B3B86E59274D}"/>
              </a:ext>
            </a:extLst>
          </p:cNvPr>
          <p:cNvSpPr txBox="1"/>
          <p:nvPr/>
        </p:nvSpPr>
        <p:spPr>
          <a:xfrm>
            <a:off x="2361383" y="581204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X</a:t>
            </a:r>
          </a:p>
        </p:txBody>
      </p:sp>
      <p:pic>
        <p:nvPicPr>
          <p:cNvPr id="10" name="图片 40">
            <a:extLst>
              <a:ext uri="{FF2B5EF4-FFF2-40B4-BE49-F238E27FC236}">
                <a16:creationId xmlns:a16="http://schemas.microsoft.com/office/drawing/2014/main" id="{9459F50A-88E4-13DD-0F63-E169C47C4F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09288" y="950536"/>
            <a:ext cx="4665022" cy="2556234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170B9B8-D9B2-4240-0C1D-D161F5CD72A8}"/>
              </a:ext>
            </a:extLst>
          </p:cNvPr>
          <p:cNvSpPr txBox="1"/>
          <p:nvPr/>
        </p:nvSpPr>
        <p:spPr>
          <a:xfrm>
            <a:off x="7707983" y="639394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X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129232A-636F-BACB-AE06-ECCC08A421F9}"/>
              </a:ext>
            </a:extLst>
          </p:cNvPr>
          <p:cNvSpPr txBox="1"/>
          <p:nvPr/>
        </p:nvSpPr>
        <p:spPr>
          <a:xfrm>
            <a:off x="508087" y="4787425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8C0A760C-79A7-944D-8C23-2850056EAC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8701" y="3759722"/>
            <a:ext cx="4318685" cy="2517073"/>
          </a:xfrm>
          <a:prstGeom prst="rect">
            <a:avLst/>
          </a:prstGeom>
        </p:spPr>
      </p:pic>
      <p:pic>
        <p:nvPicPr>
          <p:cNvPr id="14" name="图片 44">
            <a:extLst>
              <a:ext uri="{FF2B5EF4-FFF2-40B4-BE49-F238E27FC236}">
                <a16:creationId xmlns:a16="http://schemas.microsoft.com/office/drawing/2014/main" id="{DE369603-7501-3919-B3BB-FB56767A7A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09287" y="3767575"/>
            <a:ext cx="4665021" cy="2466601"/>
          </a:xfrm>
          <a:prstGeom prst="rect">
            <a:avLst/>
          </a:prstGeom>
          <a:noFill/>
          <a:ln>
            <a:noFill/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C45EF26-B6DE-08B6-6337-9E6F5BD57FED}"/>
              </a:ext>
            </a:extLst>
          </p:cNvPr>
          <p:cNvSpPr txBox="1"/>
          <p:nvPr/>
        </p:nvSpPr>
        <p:spPr>
          <a:xfrm>
            <a:off x="545096" y="191938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7011351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46">
            <a:extLst>
              <a:ext uri="{FF2B5EF4-FFF2-40B4-BE49-F238E27FC236}">
                <a16:creationId xmlns:a16="http://schemas.microsoft.com/office/drawing/2014/main" id="{68145E82-27D6-4249-9C99-0FE7479489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7873" y="96341"/>
            <a:ext cx="4500242" cy="2458323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图片 47">
            <a:extLst>
              <a:ext uri="{FF2B5EF4-FFF2-40B4-BE49-F238E27FC236}">
                <a16:creationId xmlns:a16="http://schemas.microsoft.com/office/drawing/2014/main" id="{0E838626-415E-818E-884C-019A47FBB5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05225" y="96340"/>
            <a:ext cx="4499389" cy="2458323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49">
            <a:extLst>
              <a:ext uri="{FF2B5EF4-FFF2-40B4-BE49-F238E27FC236}">
                <a16:creationId xmlns:a16="http://schemas.microsoft.com/office/drawing/2014/main" id="{769F4887-7C24-A63E-80C7-5B781FCCC9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7873" y="2865281"/>
            <a:ext cx="4486260" cy="2458323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46790E7-698B-511B-DC04-C5C37BF32C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05225" y="2865281"/>
            <a:ext cx="4483980" cy="245832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84D8B90-A584-0543-D6FC-4E1E453BFE17}"/>
              </a:ext>
            </a:extLst>
          </p:cNvPr>
          <p:cNvSpPr txBox="1"/>
          <p:nvPr/>
        </p:nvSpPr>
        <p:spPr>
          <a:xfrm>
            <a:off x="537883" y="1094668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F1F2102-F199-CF8B-F921-8E7964E8DFBB}"/>
              </a:ext>
            </a:extLst>
          </p:cNvPr>
          <p:cNvSpPr txBox="1"/>
          <p:nvPr/>
        </p:nvSpPr>
        <p:spPr>
          <a:xfrm>
            <a:off x="522654" y="374793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C42B8F-F84E-6A2B-F16E-1FBF7F601359}"/>
              </a:ext>
            </a:extLst>
          </p:cNvPr>
          <p:cNvSpPr txBox="1"/>
          <p:nvPr/>
        </p:nvSpPr>
        <p:spPr>
          <a:xfrm>
            <a:off x="744718" y="5524355"/>
            <a:ext cx="1012438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黑体" panose="02010609060101010101" pitchFamily="49" charset="-122"/>
              </a:rPr>
              <a:t>A: </a:t>
            </a:r>
            <a:r>
              <a:rPr lang="en-US" dirty="0">
                <a:latin typeface="Times New Roman" panose="02020603050405020304" pitchFamily="18" charset="0"/>
                <a:ea typeface="黑体" panose="02010609060101010101" pitchFamily="49" charset="-122"/>
              </a:rPr>
              <a:t>H</a:t>
            </a:r>
            <a:r>
              <a:rPr lang="en-US" sz="1800" dirty="0">
                <a:effectLst/>
                <a:latin typeface="Times New Roman" panose="02020603050405020304" pitchFamily="18" charset="0"/>
                <a:ea typeface="黑体" panose="02010609060101010101" pitchFamily="49" charset="-122"/>
              </a:rPr>
              <a:t>ealthy adjacent tissue to adenocarcinoma tissue, B: </a:t>
            </a:r>
            <a:r>
              <a:rPr lang="en-US" dirty="0">
                <a:latin typeface="Times New Roman" panose="02020603050405020304" pitchFamily="18" charset="0"/>
                <a:ea typeface="黑体" panose="02010609060101010101" pitchFamily="49" charset="-122"/>
              </a:rPr>
              <a:t>A</a:t>
            </a:r>
            <a:r>
              <a:rPr lang="en-US" sz="1800" dirty="0">
                <a:effectLst/>
                <a:latin typeface="Times New Roman" panose="02020603050405020304" pitchFamily="18" charset="0"/>
                <a:ea typeface="黑体" panose="02010609060101010101" pitchFamily="49" charset="-122"/>
              </a:rPr>
              <a:t>denocarcinoma tissue </a:t>
            </a:r>
          </a:p>
          <a:p>
            <a:r>
              <a:rPr lang="en-US" sz="1800" dirty="0">
                <a:effectLst/>
                <a:latin typeface="Times New Roman" panose="02020603050405020304" pitchFamily="18" charset="0"/>
                <a:ea typeface="黑体" panose="02010609060101010101" pitchFamily="49" charset="-122"/>
              </a:rPr>
              <a:t>C: Healthy adjacent tissue to squamous carcinoma tissue, D: </a:t>
            </a:r>
            <a:r>
              <a:rPr lang="en-US" dirty="0">
                <a:latin typeface="Times New Roman" panose="02020603050405020304" pitchFamily="18" charset="0"/>
                <a:ea typeface="黑体" panose="02010609060101010101" pitchFamily="49" charset="-122"/>
              </a:rPr>
              <a:t>S</a:t>
            </a:r>
            <a:r>
              <a:rPr lang="en-US" sz="1800" dirty="0">
                <a:effectLst/>
                <a:latin typeface="Times New Roman" panose="02020603050405020304" pitchFamily="18" charset="0"/>
                <a:ea typeface="黑体" panose="02010609060101010101" pitchFamily="49" charset="-122"/>
              </a:rPr>
              <a:t>quamous carcinoma tissu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5752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Widescreen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upplementary 2: HMGB-1 protein expression by Immunohistochemistry in NSCLC.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P</dc:creator>
  <cp:lastModifiedBy>HP</cp:lastModifiedBy>
  <cp:revision>1</cp:revision>
  <dcterms:created xsi:type="dcterms:W3CDTF">2024-10-27T03:48:01Z</dcterms:created>
  <dcterms:modified xsi:type="dcterms:W3CDTF">2024-10-27T03:48:12Z</dcterms:modified>
</cp:coreProperties>
</file>